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8"/>
  </p:notesMasterIdLst>
  <p:handoutMasterIdLst>
    <p:handoutMasterId r:id="rId29"/>
  </p:handoutMasterIdLst>
  <p:sldIdLst>
    <p:sldId id="260" r:id="rId2"/>
    <p:sldId id="276" r:id="rId3"/>
    <p:sldId id="278" r:id="rId4"/>
    <p:sldId id="258" r:id="rId5"/>
    <p:sldId id="282" r:id="rId6"/>
    <p:sldId id="265" r:id="rId7"/>
    <p:sldId id="266" r:id="rId8"/>
    <p:sldId id="263" r:id="rId9"/>
    <p:sldId id="283" r:id="rId10"/>
    <p:sldId id="261" r:id="rId11"/>
    <p:sldId id="257" r:id="rId12"/>
    <p:sldId id="259" r:id="rId13"/>
    <p:sldId id="272" r:id="rId14"/>
    <p:sldId id="269" r:id="rId15"/>
    <p:sldId id="270" r:id="rId16"/>
    <p:sldId id="256" r:id="rId17"/>
    <p:sldId id="280" r:id="rId18"/>
    <p:sldId id="281" r:id="rId19"/>
    <p:sldId id="273" r:id="rId20"/>
    <p:sldId id="264" r:id="rId21"/>
    <p:sldId id="274" r:id="rId22"/>
    <p:sldId id="275" r:id="rId23"/>
    <p:sldId id="268" r:id="rId24"/>
    <p:sldId id="271" r:id="rId25"/>
    <p:sldId id="279" r:id="rId26"/>
    <p:sldId id="277" r:id="rId2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6" scaleToFitPaper="1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24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notesMaster" Target="notesMasters/notesMaster1.xml"/><Relationship Id="rId29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printerSettings" Target="printerSettings/printerSettings1.bin"/><Relationship Id="rId31" Type="http://schemas.openxmlformats.org/officeDocument/2006/relationships/presProps" Target="presProps.xml"/><Relationship Id="rId32" Type="http://schemas.openxmlformats.org/officeDocument/2006/relationships/viewProps" Target="viewProps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theme" Target="theme/theme1.xml"/><Relationship Id="rId34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AB3605-547C-9E48-BFAC-B499067D379A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16C46E-8366-3F4B-A878-EC723E3F6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11132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902E02-BBF6-7241-BD41-AF20CDFC2FE2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07E506-CEAD-8243-9C74-FD6AD27C24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1826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280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637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795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008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454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497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297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35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060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429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829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861B07-FBCD-7049-B611-A4D64563F7B3}" type="datetimeFigureOut">
              <a:rPr lang="en-US" smtClean="0"/>
              <a:t>08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6CF15-905D-5443-9314-19977D488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422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154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cat              CACATGATAAATTGCCCTGTCAACAGAATTCATTCAGGGACCAATTAATTCCACAGAAAT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CACATGATAAATTGCCT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platypus         CACATGATAAATTGCCCTGTCAACAGAATC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cken          CACATGATAAATTGCCCTGTCAACAGAATTCATTCAGGGACCAATTAATTCCA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CACATGATAAATTGCTCTGTCAACGGTATTCATTCAGGGACCAATTAATTCCGCAGAAAT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CACATGATGAATTGCCCTGTCAACAGAATTCATTCAGGGACCAATTAATTCAGCAGAAAT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CACATGATGAATTGCCCTGTCAACAGAATTCATTCAGGGACCAATTAATTCAGCAGAAAT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CACATGATGAATTGCCCTGTCAACAGAATTCATTCAGGGACCAATTAATTCAG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CACATGATGAATTGCCCTGTCAACAGAATTCATTCAGGGACCAATTAATTCAGCAGAAAT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CACATGATGAATTGCCCTGTCAACAGAATTCATTCAGGGACCAATTAATTCAG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CACATGATGAATTGCCCTGTCAACGGTATTCATTCAGGGACCAATTAATTCCGCAGAAAT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******** ******  ******* * ** *********************  *******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9665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X2.99</a:t>
            </a:r>
          </a:p>
        </p:txBody>
      </p:sp>
      <p:sp>
        <p:nvSpPr>
          <p:cNvPr id="6" name="Rectangle 5"/>
          <p:cNvSpPr/>
          <p:nvPr/>
        </p:nvSpPr>
        <p:spPr>
          <a:xfrm>
            <a:off x="3492500" y="872066"/>
            <a:ext cx="558800" cy="4154982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362200" y="894745"/>
            <a:ext cx="952500" cy="413230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2082800" y="40005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Right Arrow 8"/>
          <p:cNvSpPr/>
          <p:nvPr/>
        </p:nvSpPr>
        <p:spPr>
          <a:xfrm>
            <a:off x="2362200" y="25400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ight Arrow 10"/>
          <p:cNvSpPr/>
          <p:nvPr/>
        </p:nvSpPr>
        <p:spPr>
          <a:xfrm>
            <a:off x="3492500" y="25400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2770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dog              TCAATTACAGAGTAATAAAGGGACATTCATCATTCAATTAGGCACCTGTCATGGTTTCAC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elephant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cken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armadillo        TCAATTACAGT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TCAATTACAGAGTAATAAAGGGACATTCATCATTCAATTAGGCACCTGTCATGGTTT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TCAATTACAGAGTAATAAAGGGACATTCATCATTCAATTAGGCACCTGTCA-GGCTTCAC 5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TCAATTACAGAGTAATAAAGGGACATTCATCATTCAATTAGGCACCTGTCAGTATTTCT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TCAATTACAAAGAAATAAAGGGACATTCATCATTCAATTAGGCACCTGTCA--------- 5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TCAATTACAAAGAAATAAAGGGACATTCATCATTCAATTAGGCACCTGTCAGGGCT-CAC 59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TCAATTAGAGCATAATAAAGGGACATTCATCATTCAATTAGGCATCTGTCACCGCGCCAC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TCAATTAGAGCGCAATAAAGGGACATTCATCATTCAATTAGGCATCTGTCACCACGCCAC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TCAATTAGGGCGTAATGAAGGAACATTCATCATTCAATTAGGCATCTGTCACTGAGACAC 60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TCAATTACAGCGTGATAAAGGAACATTCATCATTCAATTAGGCATCTGTCACGAATCCAC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*******       ** **** ********************** ****** 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228084"/>
            <a:ext cx="13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IS1.1731</a:t>
            </a:r>
          </a:p>
        </p:txBody>
      </p:sp>
      <p:sp>
        <p:nvSpPr>
          <p:cNvPr id="6" name="Rectangle 5"/>
          <p:cNvSpPr/>
          <p:nvPr/>
        </p:nvSpPr>
        <p:spPr>
          <a:xfrm>
            <a:off x="6159500" y="894746"/>
            <a:ext cx="558800" cy="4708980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000500" y="894746"/>
            <a:ext cx="952500" cy="468630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82800" y="41275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6159500" y="26670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Arrow 14"/>
          <p:cNvSpPr/>
          <p:nvPr/>
        </p:nvSpPr>
        <p:spPr>
          <a:xfrm>
            <a:off x="4000500" y="26670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9204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chicken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elephant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armadillo        -CCCCCATTCATCATACCCCTTTAGAAATATAAACC-AACTGTCAGCTCTAACCTAACAA 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-CCCCCATTCATCATACCCCTTTAGAAATATATCTCTAAG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platypus         -CCCCCATTCATCATACCCCTTTAGAAATATAAA-CAAACTGTCAGCTCTAACC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-CCCCCATTCATCATACCCCTTTAGAAATATAAA-CAAACTGTCAGCTGTAACCTAACAA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-CCCCCATTCATCATACCCCTTTAGAAATATAAA-CAAACTGTCAGCTGTAACCTAACAA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-CCCCCATTCATCATACCCCTTTAGAAATATAAA-CAAACTGTCAGCTGTAACCTAACAA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-CCCCCATTCATCATACCCCTTTAGAAATATAAA-CAAACTGTCAGCTGTAACCTAACAA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-CCGCCATTCATCATACCACTGTAAGAATATAAA-CAAACTGTCAGCTCTAACCTAACAA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-CCCCCATTCATCATACTCCTTAAGAAATATAAA-CAAACTGTCAGGTCTAACGTAACAA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TGC-CCATCCATCATACCCCTCAGGAAACACAAA-CAAACTGTCAGCTCTAGCGTAACAA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CGC-CCATCCATCATAGCCCTCAGGAAACACAAA-CAAACTGTCAGCTCTAGCGTAACAA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-GCACCATCCATCATGCTCCTCAAGAAACATAAA-CAAACTGTCAGCTCTAGCGTAACAA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-GCCCCATCCATCATACTCCTCAAGAAACATAAA-CAAACTGTCAGCTCTAGCGTAACAA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  * **** ******    **     ** * *   * ** ****** * ** * ******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89984"/>
            <a:ext cx="1200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X9.2099</a:t>
            </a:r>
          </a:p>
        </p:txBody>
      </p:sp>
      <p:sp>
        <p:nvSpPr>
          <p:cNvPr id="6" name="Rectangle 5"/>
          <p:cNvSpPr/>
          <p:nvPr/>
        </p:nvSpPr>
        <p:spPr>
          <a:xfrm>
            <a:off x="5600700" y="872066"/>
            <a:ext cx="558800" cy="4708980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400300" y="894746"/>
            <a:ext cx="952500" cy="468630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Straight Connector 2"/>
          <p:cNvCxnSpPr/>
          <p:nvPr/>
        </p:nvCxnSpPr>
        <p:spPr>
          <a:xfrm>
            <a:off x="2082800" y="37465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5600700" y="22860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2400300" y="22860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7246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295462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armadillo        GCATCCAGTGACAAAGATTACTGTCATCCTGGCTCATCAGTTAATTCATCATTGGCAATG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GCATCCAGTGACAAAGATTACTGTCATCCTGGCTCATCAGTTAATTCATCATTGGCAATG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GCAT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GCATCCAGTGACAAAGATTACTGTCATCCTGGCTCATCAGTTAATTCATCATTGGCAATG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elephant         GCAACCAGTGACAAAGATTACTGTCATCCTGGCTCATCAGTTAATTCATCATT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GCATCCAGTGACAAAGATTACTGTCATCCGGACTTATCACTTAATTTATCACCGGC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GCATCCAGTGACAAAGATTACTGTCACCCGGGCTCATCAGTTAATTCATCATTGGCAATG 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GCATCTAGTGACAAAGATTACTGTCAGCCACCTTCGCCAGTTAATACATCATTGCCAC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GCATCTAGTGACAAAGATTACTGTCAGCCACCTTCGCCAGTTAATACATCATTGCCACTG 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GCATCTAGTGACAAAGATTACTGTCACCCTCCTCCTAGAGTTAATTCATCATTGGAAATG 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*** * ******************** **         * *****  ****  *  * **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7636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CL11A.2554</a:t>
            </a:r>
          </a:p>
        </p:txBody>
      </p:sp>
      <p:sp>
        <p:nvSpPr>
          <p:cNvPr id="6" name="Rectangle 5"/>
          <p:cNvSpPr/>
          <p:nvPr/>
        </p:nvSpPr>
        <p:spPr>
          <a:xfrm>
            <a:off x="3860800" y="867832"/>
            <a:ext cx="558800" cy="3970317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778500" y="867832"/>
            <a:ext cx="952500" cy="3947637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2082800" y="36195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ight Arrow 10"/>
          <p:cNvSpPr/>
          <p:nvPr/>
        </p:nvSpPr>
        <p:spPr>
          <a:xfrm>
            <a:off x="3860800" y="21590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5778500" y="21590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4771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937548" y="876600"/>
            <a:ext cx="6187286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at             ATGATTAATAGCCATTTGTGAAGTGATT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ATGATTAATAGCCATTTGTGAAGTGATT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ATGATTAATAGCCATTTGTGAAGTGATT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ATGATTAATAGTCATTTGTGAAGTGATA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ATGATTAATAGCCACTTGTGAAGTGATT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ATGATTAATAGCCGTTTGTGAAGTGATT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ATGATTAATAGCCGTTTGTGAAGCAATT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ATGATTAATAGCCATTTGTGGAGTGATTAATTGGTCATT-TGACAA 45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ATGATTAATAGCCATTTGTGGAGTGATTAATTGGTCATT-TGACAA 45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ATGATTAATAGCCATTTGTGGAGTGATTAATTGGTCATT-TGACAA 4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ATGATTAATAGCCATTTGTGGAGTGATTAATTGGTCATT-TGACAA 4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ATGATTAATAGCCATTGCTGGAATGATTAATTAGTGATTC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ATGATGAATAGCCATTTGTAGAGTGATTAATTAGTCATTTTGACAA 4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ATGATGGATAGCCATTTGTAGAGTGATTAATTAGTCATTTTGACAA 4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ATGATTAATAGCCATTTGTGGAGTGATTAATTAGTCATTTTGACAT 46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ATGATTAATAGCCATTTGTGAAGAGATTAATTAGCCATTTTGATAG 46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ATGATTAATTGCCATTTGCAAAATGATTAATTAGGCATTTTGACAG 4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ATGATTAATAGCGGTTTGTGAAGTGATGAATTAGCCGGCGTGACAG 4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ATGATTAATAGCTGAGTCTGAAACTATTAATTAGTCATGCTGACAT 4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ATGATTAATAGCTCCTGCTTCGGTGATTAATTAGTGTTTGTGACAG 4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ATGATTAATAGCCCCTGCTGAGGTGATTAATTAGTGTTTGTGACAG 4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ATGATTAATAGTAGCTGGCAACGTGATTAATTAGTGTTTGTGACAG 4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*****  ** *              ** **** *      ***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391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KX6.1.4281</a:t>
            </a:r>
          </a:p>
        </p:txBody>
      </p:sp>
      <p:sp>
        <p:nvSpPr>
          <p:cNvPr id="7" name="Rectangle 6"/>
          <p:cNvSpPr/>
          <p:nvPr/>
        </p:nvSpPr>
        <p:spPr>
          <a:xfrm>
            <a:off x="2559050" y="876600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138645" y="876600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1974614" y="359944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2456979" y="216434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6036574" y="216434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72168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8748" y="872066"/>
            <a:ext cx="7572506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CTATATATCACTGACCCACCCT---------TCC-CTCTTGACAGAATGACATG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CATACATCACTCGCCCTCCCAGTTGCAGTGTCAGCCCCTGACAGAATGACATGTGTCAT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CATACATCACTGACCCACCCT---------TCC-CTCCTGACAGAATGACATATGTCAT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CG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CGTCCATCACTGACCCACCCT---------TCC-CTCCTGACAGAG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CATACATCACTGACCCACCCT---------TG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CATACATCACTGACCCACCCT---------TCC-CT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CATACATCACTGACCCACCCT---------TTC-CC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CATACATCACTGACCCACCCT---------TTC-CCCCTGACAGAATGA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CATACATCACTGACCCACCCT---------CCC-CTCCTGACAGAATGGCATA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CATCCATCACGGACCCACCCT---------TCC-</a:t>
            </a:r>
            <a:r>
              <a:rPr lang="en-US" sz="1200" dirty="0" smtClean="0">
                <a:latin typeface="Courier New"/>
                <a:cs typeface="Courier New"/>
              </a:rPr>
              <a:t>CTCCTGACAGAATGACACGTGTCAT </a:t>
            </a:r>
            <a:r>
              <a:rPr lang="en-US" sz="1200" dirty="0">
                <a:latin typeface="Courier New"/>
                <a:cs typeface="Courier New"/>
              </a:rPr>
              <a:t>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CATACATCATGGACCCACCCT---------TCC-CTCCTGACAGAATGACATGTGTCAT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CATTTATCACTGACCCACCCT---------TCG-CTCCTGACATTGTGACGCG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CATACATCACAGACCCACCCT---------TCT-CTCCTGACACAATGACGTGTGTCAT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CATACATCACAGACCCACCCT---------TCT-CTCCTGACACAATGACGCGTGTCAT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CATCCATCACGCCGCCGCCCT---------TCT-CCTCTGACGCCGGGACGCCTGTCAT 5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</a:t>
            </a:r>
            <a:r>
              <a:rPr lang="en-US" sz="1200" dirty="0" smtClean="0">
                <a:latin typeface="Courier New"/>
                <a:cs typeface="Courier New"/>
              </a:rPr>
              <a:t> *  </a:t>
            </a:r>
            <a:r>
              <a:rPr lang="en-US" sz="1200" dirty="0">
                <a:latin typeface="Courier New"/>
                <a:cs typeface="Courier New"/>
              </a:rPr>
              <a:t>****     ** **</a:t>
            </a:r>
            <a:r>
              <a:rPr lang="en-US" sz="1200" dirty="0" smtClean="0">
                <a:latin typeface="Courier New"/>
                <a:cs typeface="Courier New"/>
              </a:rPr>
              <a:t>*              </a:t>
            </a:r>
            <a:r>
              <a:rPr lang="en-US" sz="1200" dirty="0">
                <a:latin typeface="Courier New"/>
                <a:cs typeface="Courier New"/>
              </a:rPr>
              <a:t>*   ***</a:t>
            </a:r>
            <a:r>
              <a:rPr lang="en-US" sz="1200" dirty="0" smtClean="0">
                <a:latin typeface="Courier New"/>
                <a:cs typeface="Courier New"/>
              </a:rPr>
              <a:t>*     * *   </a:t>
            </a:r>
            <a:r>
              <a:rPr lang="en-US" sz="1200" dirty="0">
                <a:latin typeface="Courier New"/>
                <a:cs typeface="Courier New"/>
              </a:rPr>
              <a:t>*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473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SHZ3.1.7693</a:t>
            </a:r>
          </a:p>
        </p:txBody>
      </p:sp>
      <p:sp>
        <p:nvSpPr>
          <p:cNvPr id="7" name="Rectangle 6"/>
          <p:cNvSpPr/>
          <p:nvPr/>
        </p:nvSpPr>
        <p:spPr>
          <a:xfrm>
            <a:off x="2011145" y="872067"/>
            <a:ext cx="952500" cy="4893646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862545" y="872066"/>
            <a:ext cx="558800" cy="4869757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82800" y="33909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Right Arrow 12"/>
          <p:cNvSpPr/>
          <p:nvPr/>
        </p:nvSpPr>
        <p:spPr>
          <a:xfrm>
            <a:off x="6862545" y="190501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Arrow 17"/>
          <p:cNvSpPr/>
          <p:nvPr/>
        </p:nvSpPr>
        <p:spPr>
          <a:xfrm>
            <a:off x="2011145" y="190501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1704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8748" y="872066"/>
            <a:ext cx="7572506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ow              CTTAGGGTGCCATTTATCATTTT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TAGGGTGCCATTTATCACTTTGAATATTATTTAGACT-TGCCG-TGTAAACCTCTGAG 58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TAGGGTGCCATTTATCATTTT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TAGGGTGCCATTTATCATTTT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----GGGTGCCATTTATCATTTTGAATATTATTTAGACT-TGCCG-TGTAAACCTGTAAC 5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----GGGTGCCATTTATCATTTTGAATATTATTTAGACT-TGCCG-AGTAAACCTGTAAC 5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--GGGTGCCATTTATCATTTTGAATATTATTTAGACT-TGCCG-AGTAAACCTGTAAC 54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TAGGGCGCCATTTATCATTTT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----GGGGGCCATTTATCATTTTGAATATTATTTAGACT-TGCCG-TGTAAACCTGTAAC 54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TCGGGTACCATTTATCATTTT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TCGGGTACCATTTATCATTTT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TCGGGTACCATTTATCATTTT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TCGGGTACCATTTATCATTTTGAATATTATTTAGACT-TGCCG-TGTAAACCTGTAAC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TAGGGTACCATTTATCATTTGGAATATTATTTAGACT-TGCCG-TGTAAAC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---------CCATTTATCATTTTGAATATTATTTAGACT-TGCCG-TGCAGACCTGTAAC 4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------GTGCCATTTATCATTTTGAATATTATTTAGACT-TGCCG-TGTAAAGCTGTAAC 52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TATGGTGCCATTTATCATTTTGAATATTATTTAGACT-TGCCG-TGTAAAG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TTATGGTGCCATTTATCATTTTGAATATTATTTAGACT-TGCAG-TGTAGAGCTGTAAC 5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--GGTGCCATTTGTCATTGCTAATATTATTTAGAGT-TATTG-TTAAAAGCTGTAAC 53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GGCCCTGCCATTCATCACTGCTC-TATTATTTAGACTGGATCGCTACAGAGCCGTAAC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GGCCCTGCCATTCATCACTGCTA-TATTATTTAGACTGGATTGCTACAGAGCTGTAAC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GGCCCCCCCATTCATCACTGCTA-TTTTATTTAGACTGCATGGCTACAGAGCTGTAAC 5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*****  *** *     * ********* *     *    * * *  *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473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SHZ3.1.7694</a:t>
            </a:r>
          </a:p>
        </p:txBody>
      </p:sp>
      <p:sp>
        <p:nvSpPr>
          <p:cNvPr id="7" name="Rectangle 6"/>
          <p:cNvSpPr/>
          <p:nvPr/>
        </p:nvSpPr>
        <p:spPr>
          <a:xfrm>
            <a:off x="2825750" y="872066"/>
            <a:ext cx="952500" cy="433964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862545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82800" y="36044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6862545" y="214395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Arrow 14"/>
          <p:cNvSpPr/>
          <p:nvPr/>
        </p:nvSpPr>
        <p:spPr>
          <a:xfrm>
            <a:off x="2825750" y="214395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65423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295462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horse            CACCGGACAATAAATCAAACTGTCAGTTCCCAGGTCAAAGGTTACCCATG-AAAAGTTAT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CACCGGACAATAAATCAAACTGTCAGTTCCCAGGTCAAAGG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CACCGGACAATAAATCAAACTGTCAGTTCCCAGGTCAAAGG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CACTGGACAATAAATCAAACTGTCAGTTCTCAGATCAAAGT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CACCGGACAATAAATCAAACTGTCAGTTCTCAGATCAAAGG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CACCGGACAATAAATCAAACTGTCAGTTCTCAGGTCAAAGG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CACCGGACAATAAATCAAACTGTCAGTTCTCAGGTCAAAGG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CACCGGACAATAAATCAAACTGTCAGTTCGCAGGTCAAAGGTG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elephant         CACCGGACAATAAATCAAACTGTCAGGACCCAGGTCAAGGGTC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armadillo        CACCGGACAATAAATCAAACTGTCAGGACCCAGGTCAAAGG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CACCGGACAATAAATCAAACTGTCAGTCCCTAGGTCAGAGGTCACCCATG-AG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CACCGGACAATAAATCAAACTGTCAGTCCCTAGGTCAAAGGTT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CACCGGACAATAAATCAAACTGTCAGCTCCCAGGTCAAAGGTGACC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CACCGGACAATAAATCAAACTGTCAGCTGCCGGGTCAGAGGTCGCCCGCG-AGGAGTGAC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platypus         CACTGGACAATAAATCAAACTGTCAGGATCCAGGTCAAAGGTTATG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cken          CACTGGACAATAAATCAAACTGTCAGGACCCGGGTCAAAGGTTATGCATG-A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CACTGGACAATCAATCAGACTGTCAGGGTCCAGGTCAAAGGGCATACATG-G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CAGAGGACAATAAATTAAACTGTCAAAGGCAGAGTCAGAGGTTATTCATG-GAAAGTTAT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CACTGGACAATTAATCAAGTTGTCAGCATCGAGGTCGGAGGTCCTGAAAC-AAAAGTCAG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AACAGGGTAATTAATCAAGCTGTCAAAGAGAAGGTCAAAGGTTA----------------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CATTCTTCAATTAATCAAGCTGTCAGCTTCTAGGTGAGGGGTTGTGCATGGCAGAGACAG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CATTCTTCAATTAATCAACCTGTCAGCTTCTAGGTGAGAGGTCGTGCATGGAAGAGACAG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CATTCTTCAATTAATCAAGCTGTCAGCGTCTAGGTGAGAGGTCATTCAAGGAAGAGACAG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CATTCTTCAATTAATCAAGCTGTCAGCGTCTAGGTGAGAGGTCATTCAAGGAAGAGACAG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CATTCTGCAATTAATCAAGCTGTCAGGTCCGGGGTCACAGGTCAGCCTCGCAGGAGCCAA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 *      *** *** *   *****         *    * 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86483"/>
            <a:ext cx="1325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2F2.8470</a:t>
            </a:r>
          </a:p>
        </p:txBody>
      </p:sp>
      <p:sp>
        <p:nvSpPr>
          <p:cNvPr id="6" name="Rectangle 5"/>
          <p:cNvSpPr/>
          <p:nvPr/>
        </p:nvSpPr>
        <p:spPr>
          <a:xfrm>
            <a:off x="3771900" y="872066"/>
            <a:ext cx="558800" cy="4893646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616200" y="884766"/>
            <a:ext cx="952500" cy="4880946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2082800" y="371149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ight Arrow 10"/>
          <p:cNvSpPr/>
          <p:nvPr/>
        </p:nvSpPr>
        <p:spPr>
          <a:xfrm>
            <a:off x="3771900" y="22509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2616200" y="225099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82805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54476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ugu             CATGAAATGACAGGAATCATTGGCATACATTTCAAACAGCCTTGCGCTATCCTATTAAAG 17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ATGAAATGACAGGAATCATTGGCATACATTTCAAACAGCCTTGCGCTATCCTATTAAAG 17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ATGAAATGACAGGAATCATTGGCATACATTTCAAACAGCCTCGCGATATCCTATTAAAG 17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ATGAAATGACAGGAATCATTGGCATACATTTCAAACAGCCTTGCGCTACCCTATTAAAG 17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ATGAAATGACAGGAATCATTGGCATACATTTCAAATAGCTCT-CTCAATCCTATTAAAG 175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ATGAAATGACAGGAATCATTGGCATACATTTCAAATAGCTCT-CTCAATCCTATTAAAG 176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ATGAAATGACAGGAATCATTGGCATACATTTCAAATAGCTCT-CTCAATCCCATTAAAG 176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ATGAAATGACAGGCATCATTGGCATACATTTCAAATAGCTCT-CTCAATCCTATTAAAG 17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ATGAAATGACAGGAATCATTGGCATACATTTCAAATAGCTCT-CTCA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ATGAAATGACAGGAATCATTGGCATACATTTCAAATAGCTCT-CTCGATCCT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ATGAAATGACAGGAATCATTGGCATACATTTCAAATAGCTCT-TTCAATCCTATTAAAG 175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TGAAATGACAGGAATCATTGGCATACATTTCAAAGAGCTCT-CTCAATCCTATTAGAG 176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ATGAAATGACAGGAATCATTGGCATACATTTCAAAGAGCTCT-CTCAATCCCATTAAAG 177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ATGAAATGACAGGAATCATTGGCATACATTTCAAATAGCTTT-AGCGATCCTATTAAAG 17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ACGAAATGACAGGAATCATTGGCATACATTTCAAACAGCTTG-CACGATCCCATTAAAG 175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*********** ********************* ***        * ** **** **</a:t>
            </a: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534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NC2.8642 (1) </a:t>
            </a:r>
            <a:endParaRPr lang="en-US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2032000" y="599513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2672546" y="853747"/>
            <a:ext cx="558800" cy="468345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2672546" y="5851620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73181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fugu             </a:t>
            </a:r>
            <a:r>
              <a:rPr lang="en-US" sz="1200" dirty="0">
                <a:latin typeface="Courier New"/>
                <a:cs typeface="Courier New"/>
              </a:rPr>
              <a:t>TGCC-ACA-TCCCCACTTTAAAACAGACAAGAAGGAATCCG--CTTTGATAGATAGAGAC 23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CCTACA-TCCCCACTTTAAAACAGACAAGAACGAATCCG--CTTTGATAGATAGAGAC 235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CC-ACA-TCCCCACTTTAAAACAGACAAGAAGGAATCCG--CTTTGATAGATGGAGAC 23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CC-ACA-TCCCC-CTTTAAAACAGACAAGAAGGAGTCTG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TT-GCA-GTCCTGCTTTAAAATAGACAAGTATGAAACAA--CTTTGATAGATAGAGAC 231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TT-GCA-GTCCTGCTTTAAAATAGACAAGTATGAAACAA--CTTTGATAGATAGAGAC 232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platypus         T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TT-GCA-GT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TT-GCA-GTCCTGCTTTAAAAC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TT-GCA-GTCTTGCTTTAAAACAGACAAGGGTGAGACAA--CGTTGATAGATAGAGAC 232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TT-GCA-GTCTTGCTTTAAAATAGACAAGGAGGAAACAA--CGTTGATAGATAGAGAC 23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ATT-GCA-GTT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ATT-GCA-GCCCTGCTTTAAAATAGACAAGTATGAAACAA--CTTTGATAGATAGAGAC 233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TT-GCG-GCCCTGCTTTAAAATAGACAAGTATGAAACAA--CTTTGATAGATAGAGAC 231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TT-GCA-GCCTTGCTCTAAAATAGACAAGTATGAAACAA--CTTTGATAGATAGAGAC 232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TT-GCA-GCCCTACTTTAAAATAGACAAGTATGAAGCAA--GTTTGATGGAGAAAGGC 233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CT-GCA--TCCCACCTTAAAACTGACATGTATGAAAAAAAACTTTGATAGATAGAGAC 23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CC-ACATACTCCACTTCAAAATAGACAAGAAAAAATCCA--CTTTGATAGATAGAGAC 232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*        *   ****  **** *    *         ***** **   **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534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NC2.8642 (2) 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6216356" y="927145"/>
            <a:ext cx="952500" cy="465390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/>
          <p:cNvCxnSpPr/>
          <p:nvPr/>
        </p:nvCxnSpPr>
        <p:spPr>
          <a:xfrm>
            <a:off x="2032000" y="6064376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ight Arrow 9"/>
          <p:cNvSpPr/>
          <p:nvPr/>
        </p:nvSpPr>
        <p:spPr>
          <a:xfrm>
            <a:off x="6216356" y="5920866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83124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0"/>
            <a:ext cx="9144000" cy="11988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78748" y="872066"/>
            <a:ext cx="7664854" cy="93256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human   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GTGATGGATATAAACCTACAAAGAACCTAAACTGAACCTTTTAACAG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GTGATGGATATAAACCTATAAAGAACCTAAACTGAACCTTTTAACAATCCG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GTGATGGATATAAACCTATAAAGATCCTAAACTGGAG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GTGATGGATATAAACCTATAAAGATCCTAAACTGGAGCTTTTAACAATCCAC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AGTGATGGATATAAACCTATAAAGA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GTGATGGATATAAAC-TATAAAGAACCTAAACTGAACCTTTTAACAATCCAGGAGCAA 59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AGTGATGGCTATAAACCTATAAAGTACCTAAACTGAACCTTTTAACAAT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GTGATGGATATAAACCTATAAAGTACCTAAACCGAACCTTTTAACAATCCATGAG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GATGATGGATGTAAACCTATAAAGTATCTAAACTGGACCTTTTAACAAACCAC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GATGATGGATGTAAACCTATAAAGTATCTAAACTGGACCTTTTAACAAACCACGAG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CATGATGGATGTAAACCTATAAAGTATCTAAACTGGTCCTTTTAACAAACCATGAG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CATGATGGATGTAAACCTATAAAGTATCTAAACTGGTCCTTTTAACAAACCATGAGCA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GATGATGGATGTAAACCTATAAAGTATCTAAACTGGACCTTTTAACAAACCATGAGCA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****** * ***** ** ****   ****** *   *********  **  *****</a:t>
            </a:r>
            <a:r>
              <a:rPr lang="en-US" sz="1200" dirty="0" smtClean="0">
                <a:latin typeface="Courier New"/>
                <a:cs typeface="Courier New"/>
              </a:rPr>
              <a:t>*</a:t>
            </a: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 smtClean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  <a:p>
            <a:r>
              <a:rPr lang="en-US" sz="1200" dirty="0">
                <a:latin typeface="Courier New"/>
                <a:cs typeface="Courier New"/>
              </a:rPr>
              <a:t>human            TACTATCATTTCTTTAATAGAACCTGCTGACGGTGCCGCGCGCAGACA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CTATCATTTCTTTAATAGAACCTGCTGACGGTGCCACGCACAGACA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CTATCATTTCTTTAATAGAACCTGCTGACCGTGCCTCGCGCAGACA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TGCCATCATTTCTTTAATAGAACCTGCTGACCGCGCCTTGCACGGACA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CTATCATTTCTTTAATAGAACCTGCTGACCGCGCCTCGTGCAGACA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CTATCATTTCTTTAATAGAACCTGCTGACCGTGCCGTGCACAGGCA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CTATCATTTCTTTAATAGAACCTGCTGACCGTGCGGTGTGCAGACA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CTATCATTTCTTTAATAGAACCTGCTGACCGTGCCTTGCACAGACACCATTTGTCAC- 119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TACTATCATTTCTTTAATAGAACCTGCTGACCGTGCCTCGCACAGATGCT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ACTATCATTTCTTTAATAGAACCTGCTGACCGTGCCTTGCACAGCCG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CTATCATTTCTTTAATAGAACCTGCTGACCGTGCCTTGCACAGACACT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CTATCATTTCTTTAATAGAACCTGCTGACCGTGCCTTGCACAGACACT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ACTATCATTTCTTTAATAGAACCTGCTGACCGTGTCTTGCACAGACAT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CTATCATTTCTTTAATGGAACCCGCTGACCGTGCCCCGCGCAGACGCCATCTGTCAT- 11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CCTATCATTTCTTTAATAGAACTCGCTGACCAGGCCTTTCTCCAATGCCG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CTATCATTTCTTTAATAGAACTCACTGGCCGTGCCTTTCTCAGATGCCATTTGTCAT-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ACTATCATTTCTCTAATAGAACCTGCTGACCGTGTCATTCCCTCCTGCCATTTGTCATT 12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ACTATCATTTCTCTAATAGAACCTGCTGACCGTGTCATTCCCTCCTGCCATTTGTCAT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ACTATCATTTCTCTAATAGAACCTGCTGACCGTGTCATTCCCCGCTGCCATTCGTCAT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ACTATCATTTCTCTAATAGAACCTGCTGACCGTGTCATTCCCCGCTGCCATTCGTCATC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CTATCATTTCTTTAATAGAACCTGCTGACCGTGTCATTCCGTTCTGCCATTTGTCAT- 11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 ********* **** ****   *** *   *                *  **** </a:t>
            </a:r>
          </a:p>
        </p:txBody>
      </p:sp>
      <p:sp>
        <p:nvSpPr>
          <p:cNvPr id="6" name="Rectangle 5"/>
          <p:cNvSpPr/>
          <p:nvPr/>
        </p:nvSpPr>
        <p:spPr>
          <a:xfrm>
            <a:off x="6781800" y="6019799"/>
            <a:ext cx="558800" cy="4118187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286000" y="872066"/>
            <a:ext cx="952500" cy="413173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78748" y="138668"/>
            <a:ext cx="12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MX2.9713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2038350" y="539877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082800" y="10781187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ight Arrow 18"/>
          <p:cNvSpPr/>
          <p:nvPr/>
        </p:nvSpPr>
        <p:spPr>
          <a:xfrm>
            <a:off x="6781800" y="10635137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Arrow 11"/>
          <p:cNvSpPr/>
          <p:nvPr/>
        </p:nvSpPr>
        <p:spPr>
          <a:xfrm>
            <a:off x="2286000" y="524510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7359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572506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chimp            GTAATCCTGTAATTCCTCATTGGT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TAATCCTGTAATTCCTCATTGGT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TAATCCTGTAATTCCTCATTGGT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TAATCCTGTAATTCCTCATTGGT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TAATCCTGTAATTCCTCATTGGTGTAAAGAGAGAAAACAGAACC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TAACCCTGTAATTCCTCATTGGGGTAA-GAGAGGAAACAGAACTGTTTGTGATGAATGT 59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TAATCCTGTAATTCCTCATTGGTGTAAAGAGAGAAAACAGAACTGTTTGTGATAAATGT 60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TAATCCTGTAATTCCTCATTGGT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TAATCCTGTAATTCCTCACTGGTGTAAAGAGAGAAAACAGGACTGTCCT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TAATCCTGTAATTCCTCACTGGTGTAC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TAATCCTGCAATTCCTCATTGGCGTAAAGAGAGAAAACAGAGCTGTTTGTGATGAATGC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TAATCCTGCAATCCCTCATTGGG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TAATCCTGTAATTCCTCATTGGTGTAAAGAGAGAAAACAGAAG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CAATCCTGTAATTCCTCATTGGTGCAAAGAGAGAAAACAGAACTGTTTGTGATGAATG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TAATCCTGTAATTCCTCATTGGT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TAATCCTGTAATTCCTCATTGGTGTAAAG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TAATCTTGTAATTTCTCATTGGTGTAAAAAGAGAAAACAGAACTGTTTGTGATGAATGT 6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GAATCTTGTAATTTCTCATTGGTGTAAAGAGAGAAAACAGATCTGTTTGTGATGAATGC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TAATCTTGTAATTTCTCATTGGTGTAAAGTGGGAAAACAGAATTGTTGGTGATGAATGT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GAATGCTGTAATTTTTCACTTATGTTAAGCTTG----------TGTTTGTGATGAATGT 5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GAATCCTGTAATTTTTCACTTATGTTAAGCTTG----------TGTTTGTGATGAATGT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GAATCCTGTAATTTTTCACTTATGTTAAGCTTG----------TGTTTGTGATGAATGT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GAATCCTGTAATTTTTCACTTATGTTAAGCTTG----------TGTTTGTGATGAATGT 5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AATCCTGTAATTTTTCATCTATGTTTGGATT-----------TGCTTGTGATGAATGT 4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**   ** ***   ***     *                    *    **** 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45018"/>
            <a:ext cx="12316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XD3.327</a:t>
            </a:r>
          </a:p>
        </p:txBody>
      </p:sp>
      <p:sp>
        <p:nvSpPr>
          <p:cNvPr id="6" name="Rectangle 5"/>
          <p:cNvSpPr/>
          <p:nvPr/>
        </p:nvSpPr>
        <p:spPr>
          <a:xfrm>
            <a:off x="2565400" y="872067"/>
            <a:ext cx="558800" cy="470897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6578600" y="872067"/>
            <a:ext cx="952500" cy="470898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57400" y="373381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6565900" y="227331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>
            <a:off x="2552700" y="22225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91608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7089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squirrel         AATAGTGTAATCTATCAG-CGCCGTCAATCACAATGATTGATTACAGGCTGTCATAGAGA 117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bushbaby</a:t>
            </a:r>
            <a:r>
              <a:rPr lang="en-US" sz="1200" dirty="0" smtClean="0">
                <a:latin typeface="Courier New"/>
                <a:cs typeface="Courier New"/>
              </a:rPr>
              <a:t>         AATAGTGTAATCTATCAG-CGCC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elephant         AATAGTGTAATCTATCAG-CGCC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AATAGTGTAATCTATCAG-CGCCGTCAATCACAATGATTGATTACAGGCTGTCATAGAGA 11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AATAGTGTAATCTATCAG-CGCCGTCAATCACAATGATTGATTACAGGCTGTCATAGAGA 11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AATAGTGTAATCTATCAG-CGCCGTCAATCACAATGATTGATTACAGGCTGTCATAGAGA 11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AATAGTGTAATCTATCAG-CGCC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AATAGTGTAATCTATCAG-CGCC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AATAGTGTAATCTATCAG-CGCCGTCAATCACAATGATTGATTACAGGCTGTCATAGAGA 11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AATAGTGTAATCTATCAG-CGCCGTCAATCACAGTGATTGATTACAGGCTGTCATAGAGA 11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AATAGTGTAATCTATCAG-CGCC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AATAGTGTAATCTATCAG-CGCCGTCAATCACAATGATTGATTACAGGCTGTCATAGAGA 115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AATAGTGTAATCTATCAG-CGCCGTCAATCACAATGATTGATTACACGCTGTCATAGAGA 11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AATAGTGTAATCTATCAG-CGCCGTCAATCACAATGATTGATTACACGCTGTCATAGAGA 115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AATAGTGTAATCTATCAG-CGCC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armadillo        AATAGTGTAATCTATCAG-CGCT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AATAGTGTAATCTATCAG-CGCTGTCAATCACAATGATTGATTACAGGCTGTCATAGAGA 11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cken          AATAGTGTAATCTATCAG-CACTGTCAATCAAGATGATTGATTACAGGCTGTCATAGAGA 113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AATAGTATGATTTATCAG-GGCTGCCAATCTGAGTGATTGATTATTGCCTGCCAGACAGA 81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AATAGTGTAATCTATCAG-CTCTGTCAATCAGGATGATTGATTACGGCCTGTCAGAGAGG 103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AATAGTGTAATCTATCAG-TCCTGTCAATCAGGATGATTGATTATGGGCTGTCAGGGAGG 8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AATAGTGTAATCTATCAGGCCCTGTCAATCAGGATGATTGATTATGGGCTGTCGGGGAGG 113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AATAGTGTAATCTATCAG-TGGTGCCAATCAGGATGATTGATTATGGGCTGTCGGGGAGG 119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AATAGTGTAATCTATCAG-TGGTGCCAATCAGGATGATTGATTATGGGCTGTCGGGGAGG 11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****** * ** ******     * *****    **********    *** *    ** </a:t>
            </a:r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75052"/>
            <a:ext cx="1542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ZNF503.10102</a:t>
            </a:r>
          </a:p>
        </p:txBody>
      </p:sp>
      <p:sp>
        <p:nvSpPr>
          <p:cNvPr id="6" name="Rectangle 5"/>
          <p:cNvSpPr/>
          <p:nvPr/>
        </p:nvSpPr>
        <p:spPr>
          <a:xfrm>
            <a:off x="6413500" y="894745"/>
            <a:ext cx="558800" cy="468630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05400" y="894745"/>
            <a:ext cx="952500" cy="4686301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3949700" y="872066"/>
            <a:ext cx="558800" cy="4686301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82800" y="359718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5124450" y="218749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>
            <a:off x="3949700" y="21874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/>
          <p:cNvSpPr/>
          <p:nvPr/>
        </p:nvSpPr>
        <p:spPr>
          <a:xfrm>
            <a:off x="6413500" y="225099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95013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937548" y="876600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ATTGTGTGTCCTTCAGCTTGTTACACTGACACAAGCACTCCATAAATCATCATACCTA- 11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ATTGTGTGTCCTTCAGCTTGTTATACTGACACAAGCACTCCATAAATCATCATACCTA-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ATTGTGTGTCCTTCAGCTTGTTATACTGACACAAGCACTCCATAAATCATCATACCTA- 11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ATTGTGTGTCCTTCAGCTTGTTATACTGACACCAGCACTCCATAAATCATCATACCTA- 11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ATTGTGTGTCCTTCAGCTTGTTAGAGTGACAGTGCAACTCCATAAATCATAATACCTGT 116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ATTGTGTGTCCTTCAGCTTGTTAAACTGACACGGCCACTCCATAAATCATAATACCTGT 101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------------TTCAGCTTGTTAGAGTGACACCAGCACTCCATAAATCATAATACCTGT 4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ATTGTGTGTCCTTCAGCTTGTTAGAGTGACACCG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ATG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ATTGTGTGTCCTTCAGCTTGTTAGAATGGCACCG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ATTGTGTGTCCTTCAGCTTGTTAGAGTGGCACCG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ATT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ATT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ATT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ATT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ATT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ATTGTGTGTCCTTCAGCTTGTTAGAGTGACACCAGCACTCCATAAATCATAATACCTG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ATT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ATTGTGTGTCCTTCAGCTTGTTAGAGTGACACCAGCACTCCATAAATCATAATACCTGT 12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ATTGTGTGTCCTTCAGCTTGTTAGAGTGACACCAGCACTCCATAAATCATAATACCTGC 120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ATTGTGTGTCCTTCAGCTTGTTAGAGTGACACTAGCACTCCATAAATCATAATACCTGT 116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ATTGTGTGTCCTTCAGCTTGTTAGAGTGACACCAGCACTCCATAAATCATAATACCTGT 12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ATTGTGTGTCCTTCAGCCTGTTATACTGACACAAGCTCTCCATAAATCATCATATAAGC 8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 ****** ***** * ** **      ************* 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83026"/>
            <a:ext cx="1386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OXD.10479</a:t>
            </a:r>
          </a:p>
        </p:txBody>
      </p:sp>
      <p:sp>
        <p:nvSpPr>
          <p:cNvPr id="7" name="Rectangle 6"/>
          <p:cNvSpPr/>
          <p:nvPr/>
        </p:nvSpPr>
        <p:spPr>
          <a:xfrm>
            <a:off x="6227310" y="876600"/>
            <a:ext cx="952500" cy="452431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4246345" y="876600"/>
            <a:ext cx="558800" cy="4524314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1940824" y="303768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4104369" y="160258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Arrow 14"/>
          <p:cNvSpPr/>
          <p:nvPr/>
        </p:nvSpPr>
        <p:spPr>
          <a:xfrm>
            <a:off x="6085334" y="160258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96320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154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CTGGCTCTCAGCACCCTGCTGA-TGATGGATGCATTCTTGACACAGTCTT-GGTGTTTA 143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CTGACTCGGAGCAGCCTGCCAG-TGATGGATGCATTCTTGACACAGTCTG-GGTGATTA 1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CTGACTCCCAGAAGCGTGGCAG-TGATGGATGCATTCTTGACACAGTCTT-GGTGTTTA 15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CTGACTCCCAGAAGCATGGCAG-TGATGGATGCATTCTTGACACAGTCTC-GGTGTTTA 146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CTGACTATAAGAACCCATTCTG-TGATGGATGCATTCTTGACACAGTTTC-AGTGTTTG 145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CTGACTATAAGTACCCATCTCG-TGATGGATGCATTCTTGACACAGTTTC-AGTGTTTG 139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CTGACTATAAGTACCCATCCAGGTGATGGATGCATTCTTGACACAGTTTCCAGTGTTTG 143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CTGACTATAAGTACCCAGCCAG-TGATGGATGCCTTCTTGACACAGTTTC-AGTGTTTG 141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CTGACTATAAGTACCCATCTAG-TGATGGATGCATTCTTGACACAGTTTC-AGTGTTTG 141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CTGACTATAAGTACCCATCCAG-TGATGGATGCATTCTTGACACAGTTTC-AGTGTTTG 14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CTGACTATAAGTACCCATCCAG-TGATGGATGCATTCTTGACACAGTTTC-AGTGTTTG 141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CTGACTATAA-TACCCATCTAG-TGATGGATGCATTCTTGACACAGTTTC-AGTGTTTG 140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CTGACTATAAGTACCCATCTAG-TGATGGATGCATTCTTGACACAGTTTC-AGTGTTTG 141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CTGACTCTAAGTACCCATCCAG-TGATGGATGCATTCTTGACACAGTTTC-AGTGTTTG 14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CTGACTATAAGTACCCATCTAG-TGATGGATGCATTCTTGACACAGTTTC-AGTGTTTG 7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CTGACTGTAAGTACCCATCTAG-TGATGGATGCATTCTTGACACAGTTTC-AGTGTTTG 141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CTGACTCTAAGCACCCATCTAG-TGATGGATGCCTTCTTGACACAGTTTC-AGTGTTTG 141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CTGACTATAAGTACCCACGCAA-TGATGGATGCATTCTTGACACAGTTTC-AGTGTTTG 141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CTGACTATAAGTACCCGTCTAG-TGATAGATGCATTCTTGACACAGTTTC-AGTGTTTG 139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CTGACTATATGTGCCTGTCTAG-TGATGAATGCATTCTTGACACAACTTC-AGTGTTTG 141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CTGACTGTGTGCAGGCCTCTGG-TGATGGATGCTGGCTTGACACAGCCTC-AGTGTTTG 16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 **                 ****  ****   *********   *   *** 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386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OXD.10482</a:t>
            </a:r>
          </a:p>
        </p:txBody>
      </p:sp>
      <p:sp>
        <p:nvSpPr>
          <p:cNvPr id="6" name="Rectangle 5"/>
          <p:cNvSpPr/>
          <p:nvPr/>
        </p:nvSpPr>
        <p:spPr>
          <a:xfrm>
            <a:off x="5588000" y="872066"/>
            <a:ext cx="558800" cy="415498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203700" y="872066"/>
            <a:ext cx="952500" cy="415498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Straight Connector 2"/>
          <p:cNvCxnSpPr/>
          <p:nvPr/>
        </p:nvCxnSpPr>
        <p:spPr>
          <a:xfrm>
            <a:off x="2082800" y="34925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Right Arrow 9"/>
          <p:cNvSpPr/>
          <p:nvPr/>
        </p:nvSpPr>
        <p:spPr>
          <a:xfrm>
            <a:off x="4203700" y="20320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Left Arrow 10"/>
          <p:cNvSpPr/>
          <p:nvPr/>
        </p:nvSpPr>
        <p:spPr>
          <a:xfrm>
            <a:off x="5588000" y="20828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50598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dog              GGGTCACAGAAACATTAAGGCTT-TTGTCACTGTGATTAATAGCTCTTA-AGATCATCTT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GGTCACAGAAACATTAAGGCTT-TTGTCACTGTGATTAATAGCTCTTA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GGTCATGGCAACATTAAGGCTT-TTGTCACTGTGATTAATAGCTCTTT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GGTCACAGCAACATTAAGGCTT-TTGTCACTGTGATTAATAGCTCTTT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GGGTCACAGCAACATTAAGGTTT-TTGTCACTGTGATTAATAGTTCCTT-AG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GGGTCACCAAAACATTAAGGCTT-TTGTCACTGTGATTAATAGTGCTTT-AGATCATCCC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GGTCACACCTCTATTAGGGGCT-TTGTCACCGTGATTAATAGCTCTTT-CTATCATCTT 58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GGTCACACCTCCATTAAGGGCT-TTGTCACAGTGATTAATAGCCCCTT-CTATCATCTT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GATGACACCTCCATTAAGTGCT-TTGTCACAGTGATGAATCGTTTTTTTCTATCATCTT 5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GGTCACCTCTCCATTAGGGCGTGTTGTCATTGTGATTAATGGCTGGCT-CTATCATCTT 5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 * *       **** *   * ******  ***** *** *         *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73669"/>
            <a:ext cx="1246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VI1.10719</a:t>
            </a:r>
          </a:p>
        </p:txBody>
      </p:sp>
      <p:sp>
        <p:nvSpPr>
          <p:cNvPr id="7" name="Rectangle 6"/>
          <p:cNvSpPr/>
          <p:nvPr/>
        </p:nvSpPr>
        <p:spPr>
          <a:xfrm>
            <a:off x="5046445" y="890511"/>
            <a:ext cx="952500" cy="450586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4208245" y="842734"/>
            <a:ext cx="558800" cy="4529758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42895" y="358335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5006540" y="212285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Arrow 13"/>
          <p:cNvSpPr/>
          <p:nvPr/>
        </p:nvSpPr>
        <p:spPr>
          <a:xfrm>
            <a:off x="4181040" y="209744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78974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8748" y="872066"/>
            <a:ext cx="7572506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macaque          GTTGTGACAGCA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TTGTGACAGCA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TTGTGACAGCA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TTGTGACAGCACTTTTCATGATGATTTATGATTCCA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GTTGTGACAGCA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TTGTGACAGCA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TTGTGACAGCACTTTTCACGATGATTTATGATTCCGTGTTTAACTTGATTACTCCAGTG 60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GTTGTGACAGCACTTTTCATGATGATTTATGATTCCGTGTTTAACTTGATTACT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TTGTGACAGCA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TTGTGACAGCA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TTGTGACAGCACTTTTCATGATGATTTATGATTCT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TTGTGACAGCCCTTTTCATGATGATTTATGATTCCGTGTTTAACTTGATTACGCCAATG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--TGTGACAGCCCTTTTCATGATGATTTATGATTCAGTGTTTAACTTGATTACGCCAATG 5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TTGTGACAGCACTTTTCATGATGATTTATGATTCAGTGTTTAACTTGATTACTCCAC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TTGTGACAGCGCTATTCATGATGATTTATGATTCTGTGTTTAAGTTGATTACTCCAC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GTTGTGACAGCGCTATTCATGATGATTTATGATTCTGTGTTTAAGTTGATTACTCCACTG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TTGTGACAGCGCTATTCATGATGATTTATGATTCTGTGTTTAAGTTGATTACTCCAC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GTTGTGACAGCGCTATTCATGATGATTTATGATTCTGTGTTTAAGTTGATTACTCCACT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TTGTGACAGCGCTTCTCATGATGATTTATGATTCTGTGTTTAACTTGATTACTCCACTG 60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---GTGACAGCACAATTCATGATGATTTATGATTCTGTGTATAACTTGATTACTCCACTG 57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---GTGACAGCAGTTTTTATGATGATTTATGGGTCTGTGTTTAACTTGATTACTCTGCTG 57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********     * * ***********  **  *** *** ******** *   **</a:t>
            </a:r>
          </a:p>
          <a:p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487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ACH1.11206</a:t>
            </a:r>
          </a:p>
        </p:txBody>
      </p:sp>
      <p:sp>
        <p:nvSpPr>
          <p:cNvPr id="7" name="Rectangle 6"/>
          <p:cNvSpPr/>
          <p:nvPr/>
        </p:nvSpPr>
        <p:spPr>
          <a:xfrm>
            <a:off x="4006850" y="876600"/>
            <a:ext cx="952500" cy="407801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2392145" y="872066"/>
            <a:ext cx="558800" cy="408255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42895" y="34925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Right Arrow 8"/>
          <p:cNvSpPr/>
          <p:nvPr/>
        </p:nvSpPr>
        <p:spPr>
          <a:xfrm>
            <a:off x="4006850" y="20320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Arrow 11"/>
          <p:cNvSpPr/>
          <p:nvPr/>
        </p:nvSpPr>
        <p:spPr>
          <a:xfrm>
            <a:off x="2392145" y="22098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30265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8748" y="872066"/>
            <a:ext cx="7572506" cy="3231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macaque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GTGAATAGCATTAGAAACACGCTATTGTCAGACGGAATAATTAATCAAAGAGAGAAAAGA 60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TGAATAGCATTAGAAACCCGCTATTGTCAGACGGAATAATTAATCAAAGAGAGAAAAG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GTGAAAAGCATTAGAAACACGCTATTGTCAGACGGAATAATTAATCAAAGGCAAGAAAGA 6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GTGAAAAGCATTACGAACGCGCCGTTGTCACGCTGAATAATTAATCAAAGGCGGGAAAGA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GTGAAAAGCATTACGAAGGCGCTGTTGTCACACCAAATAATTAATCAAAGACAGCAAAGA 6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 *******  **  ***  ******  *  ***************     ****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590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SHZ3.1.11226</a:t>
            </a:r>
          </a:p>
        </p:txBody>
      </p:sp>
      <p:sp>
        <p:nvSpPr>
          <p:cNvPr id="7" name="Rectangle 6"/>
          <p:cNvSpPr/>
          <p:nvPr/>
        </p:nvSpPr>
        <p:spPr>
          <a:xfrm>
            <a:off x="5378450" y="842734"/>
            <a:ext cx="952500" cy="3260985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4220945" y="872066"/>
            <a:ext cx="558800" cy="3231653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42895" y="34925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4181040" y="20320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Arrow 14"/>
          <p:cNvSpPr/>
          <p:nvPr/>
        </p:nvSpPr>
        <p:spPr>
          <a:xfrm>
            <a:off x="5338545" y="20320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31911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Untitled-1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21"/>
            <a:ext cx="9144000" cy="6856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0916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019870" cy="43396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ourier New"/>
                <a:cs typeface="Courier New"/>
              </a:rPr>
              <a:t>frog             CAAGCCTCACATACATCACTTCAAATTAAATTTACATTAAGTTCA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AAGCCC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--AGCCTTCCATACATCACTTCAAATTAAATTTACATTAAGTGCTACTCCATCA 52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AGCCTTCCATACATCACTTCAAATTAAATTTACATTAAGT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AAGCCTTCCATACATCACTTCAAATTAAATTTACATTAAGTGCTACTCCATCA 5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AAGCCTTCCATACATCACTTCAAATTAAATTTACATTAAGAGCTACTCCATCA 5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AGCCTTCCATACATCACTGCAAATTAAATTTACATTAAGTGCTACTCCATCA 5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ATTGCTGCCATACATCACTCCAAATTAAATTTACATTAGGCCCTCCTCTATCA 5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CATCGCTGCCATACATCACTCCAAATTAAATTTACATTATGCCCTCCTCTATCA 54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-----CTGCCATACATCACTCCAAATTAAATTTACATTAGGCCCTCCTCTATCA 4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----</a:t>
            </a:r>
            <a:r>
              <a:rPr lang="en-US" sz="1200" dirty="0" smtClean="0">
                <a:latin typeface="Courier New"/>
                <a:cs typeface="Courier New"/>
              </a:rPr>
              <a:t>-CCATACATCACTCCAAATTAAATTTACATTAGGCCCTCCTCAATCA </a:t>
            </a:r>
            <a:r>
              <a:rPr lang="en-US" sz="1200" dirty="0">
                <a:latin typeface="Courier New"/>
                <a:cs typeface="Courier New"/>
              </a:rPr>
              <a:t>4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-----CTGCTGTACATCACTCCAAATTAAATTTACATTAGGCTCTCCTCCATCA 49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      ********* ****************** *  *  *** ****</a:t>
            </a:r>
          </a:p>
        </p:txBody>
      </p:sp>
      <p:sp>
        <p:nvSpPr>
          <p:cNvPr id="6" name="Rectangle 5"/>
          <p:cNvSpPr/>
          <p:nvPr/>
        </p:nvSpPr>
        <p:spPr>
          <a:xfrm>
            <a:off x="4864100" y="872066"/>
            <a:ext cx="558800" cy="4339649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731776" y="877332"/>
            <a:ext cx="952500" cy="4334383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Straight Connector 2"/>
          <p:cNvCxnSpPr/>
          <p:nvPr/>
        </p:nvCxnSpPr>
        <p:spPr>
          <a:xfrm>
            <a:off x="2082800" y="603250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Left Arrow 10"/>
          <p:cNvSpPr/>
          <p:nvPr/>
        </p:nvSpPr>
        <p:spPr>
          <a:xfrm>
            <a:off x="4864100" y="589153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378748" y="138668"/>
            <a:ext cx="12316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XD3.365</a:t>
            </a:r>
          </a:p>
        </p:txBody>
      </p:sp>
      <p:sp>
        <p:nvSpPr>
          <p:cNvPr id="13" name="Left Arrow 12"/>
          <p:cNvSpPr/>
          <p:nvPr/>
        </p:nvSpPr>
        <p:spPr>
          <a:xfrm>
            <a:off x="2731776" y="588645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7284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8748" y="138668"/>
            <a:ext cx="15180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XP1.886 (1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78748" y="872066"/>
            <a:ext cx="7572506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Courier New"/>
                <a:cs typeface="Courier New"/>
              </a:rPr>
              <a:t>fugu</a:t>
            </a:r>
            <a:r>
              <a:rPr lang="en-US" sz="1200" dirty="0" smtClean="0">
                <a:latin typeface="Courier New"/>
                <a:cs typeface="Courier New"/>
              </a:rPr>
              <a:t>             TAATCAAAGTTGATTTATTGTTCATTAGTAGTGCATTAG--CCCTTTCAGGCAGGGGC-G 57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TAATCAAAGTTGATTTATTGTTCATTAGTAGTGCATTAG--CCCTTTCAGGCAGGGGC-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TAATCAAAGTTGATTTATTGTTCATTAGTAGTGCATTAG--CCCTTTCAGGCAGCGGC-G 57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TAATCAAAGTTGATTTATTGTTCATTAGTAGTGCATTAG--CCCTTTCAGGCAGGAGC-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armadillo        TAATCAAAGTTGATTTATTGTTCATTAGTACTGCATTAG--CT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TAATCAAAGTTGATTTATTGTTCATTAGTACTGCATTAG--CCCTTTCAGA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elephant         TAATCAAAGTTGATTTATTGCTCATTAGTAT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TAATCAACGTTGATTTATTGTTCATTAGTAG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platypus         TAATCAAAGTTGATTTATTGTTCATTAGTAG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TAATCAAAGTTGATTTATTGTTCATTAGTACTGCATTAG--CCCTTTCAGGCAA-GACAG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TAATCAAAGTTGATTTATTGTTCATTAGTACTACATTAG--C-CTCTCAGGCAA-GACAG 56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TAATCACAGTTGATTTATTGTTCATTAGGACTGCATTAG--CCCTTTCAGGCCG-GCCAC 57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TAATCAGAGTTGATTTATTGTTCATTAGCGATGCATTAG--GCCTCTCGGGCAAAGGCAG 58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TAATCAAAGTTGATTTATTGTTCATTAGTAGTGCATTAG--CCCTTTCAGGAAA-GGCAG 57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TAATCAGACTTGATTTATTGTTCATTAGTAGTGCATTAGGGCCCGCTCTGGCTGGGGCCG 6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******   *********** *******   * ******    *  ** *       * </a:t>
            </a:r>
          </a:p>
        </p:txBody>
      </p:sp>
      <p:sp>
        <p:nvSpPr>
          <p:cNvPr id="7" name="Rectangle 6"/>
          <p:cNvSpPr/>
          <p:nvPr/>
        </p:nvSpPr>
        <p:spPr>
          <a:xfrm>
            <a:off x="2946400" y="872066"/>
            <a:ext cx="952500" cy="4639734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2038350" y="6019563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2946400" y="5876053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5763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8748" y="138668"/>
            <a:ext cx="15180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XP1.886 (2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78748" y="872066"/>
            <a:ext cx="7664854" cy="5262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/>
                <a:cs typeface="Courier New"/>
              </a:rPr>
              <a:t>fugu             T----TATTTGTGCAGTGGCC-TGTCAAGGCGAGGGGCTGCCA-GCACCTGTCATTTCCA 111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tetraodon</a:t>
            </a:r>
            <a:r>
              <a:rPr lang="en-US" sz="1200" dirty="0" smtClean="0">
                <a:latin typeface="Courier New"/>
                <a:cs typeface="Courier New"/>
              </a:rPr>
              <a:t>        T----TATTTGTGCAGTGGCC-TGTCAAGGCGAGGGGCTGCCA-GCACCTGTCATTTCCA 11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tickleback      T----TATTTGTGCAGTGGCC-TGTCAAGGCGACGGGCTGCGA-GCACCTGTCATTTCTA 111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T----TATTTGTGCAGTGGCC-TGTCAAAGCGTGGAGCTGCTA-TCACCTGTCATTTCTA 11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bbit           C----TATTTGTGTAGTGGCC-TGTCAAG-AGGC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armadillo        T----TATTTGTGTAGTGGCC-TGTCAAG-AGGG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uman            T----TATTTGTGTAGTTGCC-TGTCAAG-AGTG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himp            T----TATTTGTGTAGTTGCC-TGTCAAG-AGTG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rangutan        T----TATTTGTGTAGTTGCC-TGTCAAG-AGTG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rat              T----TATTTGTGTAGTAGCC--GTCAAG-AGTAAAACTGCAA-GCACCTGTCATTTTGA 10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ouse            T----TATTTGTGTAGTAGCC--GTCCAG-AGTGAAACTGCAA-GCACCTGTCATCTTGA 109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macaque          T----TATTTGTGTAGTGGCC-TGTCAAG-AGTG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horse            T----TATTTGTGTAGTGGCC-TGTCAAG-AACGAGACTGCAA-GCACCTGTCATTTCG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elephant         T----TATTTGTGTAGTGGCC-TGTCAAG-ATCG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at              T----TATTTGTGTAGTGGCC-TGTCAAG-AGCGAGACTGCAAAGCACCTGTCATTTCTA 111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dog              T----TATTTGTGTAGTGGCC-TGTCAAG-AGCA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opossum          T----TATTTGTGTAGTGGCC-TGTCAAG-CAAGAGACTTCT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platypus         T----TATTTGTGTAGTGGTC-TGTCAAG-CAGCAGACTGTT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cow              T----TATTTGTGTAGTGGCC-TGTCAAG-AGCAAGACTACC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quirrel         T----TATTTGTGTAGTGGCCCTGTCAGG-AGCAAGACTGCAA-GCACCTGTCATTTCC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bat              T----TATTTGTGTAGTGGCC-TGTCAAG-AGCCAGACTGCAA-GCACCTGTCATTTCTA 110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frog             T----TATTTGTGTAGCCGCC-TGTCAAA-GTGCAGAATACGA-GCACCTGTCA------ 105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shark            T----TATTTGTGCAGTGGCC-TGTCAACTACAGAGACTGCAA-GCACCTGTCATTTCTT 111</a:t>
            </a:r>
          </a:p>
          <a:p>
            <a:r>
              <a:rPr lang="en-US" sz="1200" dirty="0" err="1" smtClean="0">
                <a:latin typeface="Courier New"/>
                <a:cs typeface="Courier New"/>
              </a:rPr>
              <a:t>zfish</a:t>
            </a:r>
            <a:r>
              <a:rPr lang="en-US" sz="1200" dirty="0" smtClean="0">
                <a:latin typeface="Courier New"/>
                <a:cs typeface="Courier New"/>
              </a:rPr>
              <a:t>            AACCACATTTATGT-GTTGCCCTGACAGGCCGTGAGCCTGCCA-ACACCTGTCATTTC-- 116</a:t>
            </a:r>
          </a:p>
          <a:p>
            <a:r>
              <a:rPr lang="en-US" sz="1200" dirty="0" smtClean="0">
                <a:latin typeface="Courier New"/>
                <a:cs typeface="Courier New"/>
              </a:rPr>
              <a:t>                       **** **  *  * *  * *            *   *  ********* </a:t>
            </a:r>
          </a:p>
          <a:p>
            <a:endParaRPr lang="en-US" sz="1200" dirty="0">
              <a:latin typeface="Courier New"/>
              <a:cs typeface="Courier New"/>
            </a:endParaRPr>
          </a:p>
          <a:p>
            <a:endParaRPr lang="en-US" sz="1200" dirty="0">
              <a:latin typeface="Courier New"/>
              <a:cs typeface="Courier New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6400800" y="872066"/>
            <a:ext cx="558800" cy="4605868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2082800" y="5819484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ight Arrow 10"/>
          <p:cNvSpPr/>
          <p:nvPr/>
        </p:nvSpPr>
        <p:spPr>
          <a:xfrm>
            <a:off x="6400800" y="5672084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294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AATGGCATTTTGATTGATTTTTTTTCCCCCTCT--TCCTAATGGTCGTTTTATA-----G 29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AATGGCATTTTGATTGATTTTTTTCTCCCCTCTCTTCCTAATGGTCGTTTTATA-----G 290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AATGGCATTTTGATTGATTTTT----CCCCTCT--TCCTAATGGTCCTTTTATA-----G 282</a:t>
            </a:r>
          </a:p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AATGGCATTTTGATTGATTTTTTT--CCCCTCT--TCCTAATGGTCGTTTTATA-----G 283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AATGGCATTTTGATTGATTTTTCT-----------GCCTAATGGTAGTTTTATACTGTAC 284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AATGGCATTTTGATTGATTTTTCT-----------GCCTAATGGTAGTTTTATACTGTAG 215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AATGGCATTTTGATTGATTTTTCT-----------GCCTAATGGTAGTTTTATACTGTAG 28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AATGGCATTTTGATTGATTTTTCT-----------GCCTAATGGTAGTTTTATACTGTAG 284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AATGGCATTTTGATTGATTTTTCC-----------TCCTAATGGTAGTTTTATA-----G 273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AATGGCATTTTGATTGATTTTTCA-----------GCCTAATGGTAGTTTTATA-----G 27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AATGGCATTTTGATTGATTTTTTCTCCT-------TCTTAATGGTACTTTTATA-----G 26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*****************              * *******  ******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61873"/>
            <a:ext cx="13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IS2.1088</a:t>
            </a:r>
          </a:p>
        </p:txBody>
      </p:sp>
      <p:sp>
        <p:nvSpPr>
          <p:cNvPr id="7" name="Rectangle 6"/>
          <p:cNvSpPr/>
          <p:nvPr/>
        </p:nvSpPr>
        <p:spPr>
          <a:xfrm>
            <a:off x="2933700" y="890511"/>
            <a:ext cx="952500" cy="450586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2214345" y="866623"/>
            <a:ext cx="558800" cy="4529758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82800" y="356986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2933700" y="210936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2214345" y="208395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83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378748" y="872066"/>
            <a:ext cx="7664854" cy="4524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TGATGGATGAGGCTCTCCAATGCTGGCCGACAGCTCTGCAAATCTCTGCGGCTGCCTAAA 17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TGATGGATGAGGCTCTGCGACGCTGGCGGACAGCTCTGCAAATCTCTGCGGCTGCCTAAA 17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TGATGGATGAGGCTCTGCGACACCGGCCGACAGCTCTGCAAATCTCGGCGGCTGCCTAAA 17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tetraodon</a:t>
            </a:r>
            <a:r>
              <a:rPr lang="en-US" sz="1200" dirty="0">
                <a:latin typeface="Courier New"/>
                <a:cs typeface="Courier New"/>
              </a:rPr>
              <a:t>        TGATGGATGAGGCTCTGCAACGCCGGCCGACAGCTCTGCAAATCTCGGCGGCTGCCTAAA 179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TGATGAATGGGCCTTTCAAACACCCGGAGACAGCTCTGCAAATCTCCCCGGCTGC-TAAG 179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TGATGAATGGGCCTTTCAAACACCCGGAGACAGCTCTGCAAATCTCCCC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TGATGAATGGGCCTTTCAAACACCCGGAGACAGCTCTGCAAATCTCCCT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TGATGAATGGGCCTTTCAAACACCCGGAGACAGCTCTGCAAATCTCCCT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TGATGAATGGGCCTTTCAAACACCCGGAGACAGCTCTGCAAATCTCCCT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TGATGAATGGGCCTTTCAAACACCAGGAGACAGCTCTGCAAATCTCCCT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TGATGAATGGGCCTTTCAAACACCAGGAGACAGCTCTGCAAATCTCCCTGGCTGC-TAAA 17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TGATGAATGGGCCTTTCAAATGCCAAGAGACAGCTCTGCAAATCTCTCTGGCTGC-TGAA 17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TGATGAATGGCTCATTCAAACGCCGGGAGACAGCTCTGCAAATCTCCCCGGCTTC-CACA 176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TGATGGATGAGGCTGTTAGATGCTAGAGGACAGATCCGCAAATCTCTGCCGCTGCACAGA 161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**** ***   *  *   *  *     ***** ** *********    *** *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38668"/>
            <a:ext cx="13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IS2.1091</a:t>
            </a:r>
          </a:p>
        </p:txBody>
      </p:sp>
      <p:sp>
        <p:nvSpPr>
          <p:cNvPr id="7" name="Rectangle 6"/>
          <p:cNvSpPr/>
          <p:nvPr/>
        </p:nvSpPr>
        <p:spPr>
          <a:xfrm>
            <a:off x="1993900" y="866623"/>
            <a:ext cx="952500" cy="4505869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4500345" y="842734"/>
            <a:ext cx="558800" cy="4529758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82800" y="341632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Right Arrow 11"/>
          <p:cNvSpPr/>
          <p:nvPr/>
        </p:nvSpPr>
        <p:spPr>
          <a:xfrm>
            <a:off x="1993900" y="195582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Arrow 12"/>
          <p:cNvSpPr/>
          <p:nvPr/>
        </p:nvSpPr>
        <p:spPr>
          <a:xfrm>
            <a:off x="4500345" y="193041"/>
            <a:ext cx="558800" cy="287019"/>
          </a:xfrm>
          <a:prstGeom prst="lef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4076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11963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378748" y="872066"/>
            <a:ext cx="7572506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Courier New"/>
                <a:cs typeface="Courier New"/>
              </a:rPr>
              <a:t>medaka</a:t>
            </a:r>
            <a:r>
              <a:rPr lang="en-US" sz="1200" dirty="0">
                <a:latin typeface="Courier New"/>
                <a:cs typeface="Courier New"/>
              </a:rPr>
              <a:t>           CTGTCAGTGGGATGATAAATGACTCCATTT-CTGCCGGTGCTGCCTTCTGCCACTGGCGG 59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TGTCAGGAGGATGATAAATGACTCCATTTTCTGCCTGTGCTGCCTTCTGCCACTGGCGG 60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TGTCAGCCGGATGATAAATGACTCCATTTTCTGCCTGTGCTGCCTTCTGCCACCGGCAG 60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TGTCA-TCTCATGATAAATGACTCCATTTTCTGCCTCTCTTGCCTTCTGCCACTC-CAG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TGTCA-TCTCATGATAAATGACTCCATTTTCTGCCTT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TGTCA-TCTCATGATAAATGACTCCATTTTCTGCCTCT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TGTCA-TCTCATGATAAATGACTCCATTTTCTGCCTCTCTTGCCTTCTGCCACTC-CGG 58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TGTCA-TCTTATGATAAATGACTCCATTTTCTGCCTCCCTTGCCTTCTGCCACTC-CAG 58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CCGTCA-CTGGATGATAAATGACTCCATTTTCTGCCTTTCTTGCCTTCTGCCACTC-CAA 58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CTGTCGTCCGCATGATGAATG---------TGTGTGTGTGCTG-----TG---------- 36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* ***      ***** ****           **       **     **         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94786"/>
            <a:ext cx="1611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IS2.1102 (1)</a:t>
            </a:r>
          </a:p>
        </p:txBody>
      </p:sp>
      <p:sp>
        <p:nvSpPr>
          <p:cNvPr id="6" name="Rectangle 5"/>
          <p:cNvSpPr/>
          <p:nvPr/>
        </p:nvSpPr>
        <p:spPr>
          <a:xfrm>
            <a:off x="2019300" y="867832"/>
            <a:ext cx="558800" cy="4708980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086100" y="890512"/>
            <a:ext cx="952500" cy="4686300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2082800" y="596900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Right Arrow 13"/>
          <p:cNvSpPr/>
          <p:nvPr/>
        </p:nvSpPr>
        <p:spPr>
          <a:xfrm>
            <a:off x="2019300" y="582295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ight Arrow 16"/>
          <p:cNvSpPr/>
          <p:nvPr/>
        </p:nvSpPr>
        <p:spPr>
          <a:xfrm>
            <a:off x="3086100" y="5822950"/>
            <a:ext cx="952500" cy="287019"/>
          </a:xfrm>
          <a:prstGeom prst="righ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0748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8748" y="872066"/>
            <a:ext cx="7664854" cy="4893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Courier New"/>
                <a:cs typeface="Courier New"/>
              </a:rPr>
              <a:t>medaka</a:t>
            </a:r>
            <a:r>
              <a:rPr lang="en-US" sz="1200" dirty="0" smtClean="0">
                <a:latin typeface="Courier New"/>
                <a:cs typeface="Courier New"/>
              </a:rPr>
              <a:t>           </a:t>
            </a:r>
            <a:r>
              <a:rPr lang="en-US" sz="1200" dirty="0">
                <a:latin typeface="Courier New"/>
                <a:cs typeface="Courier New"/>
              </a:rPr>
              <a:t>CA-GAGGCCATTTATCATCATCCGCTGTCA-GCC-GTGGAAAGCAGCAGTGACAGTGCGA 116</a:t>
            </a:r>
          </a:p>
          <a:p>
            <a:r>
              <a:rPr lang="en-US" sz="1200" dirty="0">
                <a:latin typeface="Courier New"/>
                <a:cs typeface="Courier New"/>
              </a:rPr>
              <a:t>stickleback      CA-GCGCCCATTTATCATCATCCGCTGTCA-GCC-GTGGCAAGCGGCAGTGACAGTGCGA 117</a:t>
            </a:r>
          </a:p>
          <a:p>
            <a:r>
              <a:rPr lang="en-US" sz="1200" dirty="0" err="1">
                <a:latin typeface="Courier New"/>
                <a:cs typeface="Courier New"/>
              </a:rPr>
              <a:t>fugu</a:t>
            </a:r>
            <a:r>
              <a:rPr lang="en-US" sz="1200" dirty="0">
                <a:latin typeface="Courier New"/>
                <a:cs typeface="Courier New"/>
              </a:rPr>
              <a:t>             CA-GTGGCCATTTATCATCATCCGCTGTCA-GCC-GTGGAAAGCGGCAGTGACAGTGCGA 117</a:t>
            </a:r>
          </a:p>
          <a:p>
            <a:r>
              <a:rPr lang="en-US" sz="1200" dirty="0">
                <a:latin typeface="Courier New"/>
                <a:cs typeface="Courier New"/>
              </a:rPr>
              <a:t>chimp            CA-ATGGTCATTTATCATCATCT-CTGTCA-GCA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orangutan        CA-ATGGTCATTTATCATCATCT-CTGTCA-GCA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macaque          CA-ATGGTCATTTATCATCATCT-CTGTCA-GCA-ATGGAAAGCGGCACTGACAGTGCAA 114</a:t>
            </a:r>
          </a:p>
          <a:p>
            <a:r>
              <a:rPr lang="en-US" sz="1200" dirty="0" err="1">
                <a:latin typeface="Courier New"/>
                <a:cs typeface="Courier New"/>
              </a:rPr>
              <a:t>bushbaby</a:t>
            </a:r>
            <a:r>
              <a:rPr lang="en-US" sz="1200" dirty="0">
                <a:latin typeface="Courier New"/>
                <a:cs typeface="Courier New"/>
              </a:rPr>
              <a:t>         CA-ATGGTCATTTATCATCATCT-CTGTCA-GCG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bat              CA-ATGGTCATTTATCATCATCT-CTGTCA-GCA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cat              CA-ATGGTCATTTATCATCATCT-CTGTCA-GCA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horse            CA-ATGGTCATTTATCATCATCT-CTGTCA-GCA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rat              CA-GTGGTCATTTATCATCATCT-CTGTCA-GCA-GTGGGAAGCA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mouse            CA-GTGGTCATTTATCATCATCT-CTGTCA-GCA-GTGGG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cow              CA-ATGGTCATTTATCATCATCT-CTGTCA-GCA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rabbit           CA-TTGGTCATTTATCATCATCT-CTGTCA-GCA-ATGGAAAGCG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armadillo        CA-GTGGTCATTTATCATCATCT-CTGTCA-GCA-ATGGAAAGCGGCACTGTCT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human            CA-ATGGTCATTTATCATCATCT-CTGTCA-GCA-ATGGAAAGCA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squirrel         CA-ATGGTCATTTATCATCATCT-CTGTCA-GCA-ATGGAAAGCA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dog              CA-ATGGTCATTTATCATCATCT-CTGTCA-GCA-ATGGAAAGCA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elephant         CA-ATGGTCATTTATCATCATCT-CTGTCA-GCA-ATGGAAAGCAGT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opossum          CA-ATGGTCATTTATCATCATCT-CTGTCA-GCA-ATGGAAAGCAGCC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chicken          CA-ATGGTCATTTATCATCATCT-CTGTCA-GCA-ATGGAAAGCA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shark            CA-ATGGTCATTTATCATCATCT-CTGTCA-ACG-ATGGAAAGCAGCACTGACAGTGCAA 114</a:t>
            </a:r>
          </a:p>
          <a:p>
            <a:r>
              <a:rPr lang="en-US" sz="1200" dirty="0">
                <a:latin typeface="Courier New"/>
                <a:cs typeface="Courier New"/>
              </a:rPr>
              <a:t>frog             GAGAGGGTCGTTTATCATAATCT-CTGTCA-GCG-AGGGAAAGTAGCCCTGACAGTGCAA 115</a:t>
            </a:r>
          </a:p>
          <a:p>
            <a:r>
              <a:rPr lang="en-US" sz="1200" dirty="0" err="1">
                <a:latin typeface="Courier New"/>
                <a:cs typeface="Courier New"/>
              </a:rPr>
              <a:t>zfish</a:t>
            </a:r>
            <a:r>
              <a:rPr lang="en-US" sz="1200" dirty="0">
                <a:latin typeface="Courier New"/>
                <a:cs typeface="Courier New"/>
              </a:rPr>
              <a:t>            ---ATGGTCATCCATCATCGTCTGCTGTCACACACATGAAACGCGGC---GACAGCGCCA 90</a:t>
            </a:r>
          </a:p>
          <a:p>
            <a:r>
              <a:rPr lang="en-US" sz="1200" dirty="0">
                <a:latin typeface="Courier New"/>
                <a:cs typeface="Courier New"/>
              </a:rPr>
              <a:t>                      *  * *  *****  **  ******  *    *  * *  *    * * * ** 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748" y="194786"/>
            <a:ext cx="1611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IS2.1102 (2)</a:t>
            </a:r>
          </a:p>
        </p:txBody>
      </p:sp>
      <p:sp>
        <p:nvSpPr>
          <p:cNvPr id="9" name="Rectangle 8"/>
          <p:cNvSpPr/>
          <p:nvPr/>
        </p:nvSpPr>
        <p:spPr>
          <a:xfrm>
            <a:off x="2667000" y="895578"/>
            <a:ext cx="952500" cy="4570336"/>
          </a:xfrm>
          <a:prstGeom prst="rect">
            <a:avLst/>
          </a:prstGeom>
          <a:noFill/>
          <a:ln w="38100" cmpd="sng"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4216400" y="872898"/>
            <a:ext cx="558800" cy="4593016"/>
          </a:xfrm>
          <a:prstGeom prst="rect">
            <a:avLst/>
          </a:prstGeom>
          <a:noFill/>
          <a:ln w="38100" cmpd="sng"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Connector 15"/>
          <p:cNvCxnSpPr/>
          <p:nvPr/>
        </p:nvCxnSpPr>
        <p:spPr>
          <a:xfrm>
            <a:off x="2082800" y="5906760"/>
            <a:ext cx="54737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ight Arrow 18"/>
          <p:cNvSpPr/>
          <p:nvPr/>
        </p:nvSpPr>
        <p:spPr>
          <a:xfrm>
            <a:off x="4216400" y="5760710"/>
            <a:ext cx="558800" cy="292100"/>
          </a:xfrm>
          <a:prstGeom prst="rightArrow">
            <a:avLst/>
          </a:prstGeom>
          <a:solidFill>
            <a:schemeClr val="accent1"/>
          </a:solidFill>
          <a:ln>
            <a:solidFill>
              <a:schemeClr val="accent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Left Arrow 19"/>
          <p:cNvSpPr/>
          <p:nvPr/>
        </p:nvSpPr>
        <p:spPr>
          <a:xfrm>
            <a:off x="2667000" y="5760710"/>
            <a:ext cx="952500" cy="292100"/>
          </a:xfrm>
          <a:prstGeom prst="leftArrow">
            <a:avLst/>
          </a:prstGeom>
          <a:solidFill>
            <a:schemeClr val="accent2"/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288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56</TotalTime>
  <Words>4679</Words>
  <Application>Microsoft Macintosh PowerPoint</Application>
  <PresentationFormat>On-screen Show (4:3)</PresentationFormat>
  <Paragraphs>648</Paragraphs>
  <Slides>2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2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ationl Institute for Medical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Grice</dc:creator>
  <cp:lastModifiedBy>Joseph Grice</cp:lastModifiedBy>
  <cp:revision>95</cp:revision>
  <dcterms:created xsi:type="dcterms:W3CDTF">2013-01-08T15:08:50Z</dcterms:created>
  <dcterms:modified xsi:type="dcterms:W3CDTF">2015-04-08T14:47:27Z</dcterms:modified>
</cp:coreProperties>
</file>